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5120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561A19-6EE0-4282-BAD3-3240754023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822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29599200"/>
            <a:ext cx="822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939FE-FE7D-4101-9524-75E079D20A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2959920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2959920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2632A-A9CD-42BB-AD82-0CB5D7FF29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194768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194768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2959920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2959920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29599200"/>
            <a:ext cx="264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044C0-7DA2-48B7-A646-C8067E7F93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1947680"/>
            <a:ext cx="8229600" cy="3379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723DE-92FC-4B2C-8937-5BD7A2B3B5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82296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41DEA-FAA2-4290-A349-302979B0F8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40158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1947680"/>
            <a:ext cx="40158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BFF1C-6DB0-4774-8883-C30C9AE10E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C38F6-BA2F-4518-9319-84595E91BA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050560"/>
            <a:ext cx="8229600" cy="3956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F1CBD-0B98-4543-9FE8-5246D2A1C6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1947680"/>
            <a:ext cx="40158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2959920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DED53-095A-40E7-997C-EBBAB94BEA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40158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2959920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9A1591-0A01-4FC8-B91F-03D5903712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1947680"/>
            <a:ext cx="40158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29599200"/>
            <a:ext cx="82296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8BDAA3-B86E-47C0-BA36-1728B04730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050560"/>
            <a:ext cx="82296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1947680"/>
            <a:ext cx="82296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46631160"/>
            <a:ext cx="213372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46631160"/>
            <a:ext cx="289584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46631160"/>
            <a:ext cx="213372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45D8B1-C609-48A1-B380-ED9D495A25EF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2"/>
          <p:cNvPicPr/>
          <p:nvPr/>
        </p:nvPicPr>
        <p:blipFill>
          <a:blip r:embed="rId1"/>
          <a:srcRect l="0" t="0" r="11889" b="702"/>
          <a:stretch/>
        </p:blipFill>
        <p:spPr>
          <a:xfrm>
            <a:off x="0" y="0"/>
            <a:ext cx="4788000" cy="510220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1314360" y="54000"/>
          <a:ext cx="5865840" cy="50645880"/>
        </p:xfrm>
        <a:graphic>
          <a:graphicData uri="http://schemas.openxmlformats.org/drawingml/2006/table">
            <a:tbl>
              <a:tblPr/>
              <a:tblGrid>
                <a:gridCol w="5605560"/>
                <a:gridCol w="260280"/>
              </a:tblGrid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ATE BLIGHT RESISTANCE PROTEIN RPI-BLB2 [SOLANUM BULBOCASTAN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OOT-KNOT NEMATODE RESISTANCE PROTEIN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BL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RO RESISTANCE PROTEIN 1 HOMOLOGU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RO RESISTANCE PROTEIN 1 HOMOLOGU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ERO RESISTANCE PROTEIN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RO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ERO RESISTANCE PROTEIN 1 HOMOLOGU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CODING RESISTANCE GENE ANALOG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C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CODING RESISTANCE GENE ANALOG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C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D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B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B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C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B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B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OSPOVIRUS RESISTANCE PROTEIN A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SPOVIRUS RESISTANCE PROTEIN 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RF [SOLANUM PIMPINELLIFOLI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LATE BLIGHT RESISTANCE PROTEIN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LATE BLIGHT RESISTANCE PROTEIN HOMOLOG R1B-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AF447489_1 LATE BLIGHT RESISTANCE PROTEIN [SOLANUM DEMISS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LATE BLIGHT RESISTANCE PROTEIN HOMOLOG R1B-2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DISEASE RESISTANCE PROTEIN BS2 [CAPSICUM CHACOENS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CODING RESISTANCE GENE ANALOG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BS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/LRR RESISTANCE PROTEIN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GC1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GPA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GPA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GC1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PROTEIN PSH-RGH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X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X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DISEASE RESISTANCE PROTEIN GPA2 [SOLANUM TUBEROS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BS-LRR PROTEIN [SOLANUM ACAUL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X PROTEIN [SOLANUM TUBEROS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R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-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-2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M-2 TOMV RESISTANCE PROTEIN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M-2^2 TOMV RESISTANCE PROTEIN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-VNT1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P13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JTR2GH1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2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JTR2GH1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KR2GH5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DNR2GH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KR2GH5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JTR2GH1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DNR2GH7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DNR2GH7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KR2GH5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2 LATE BLIGHT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NKR2GH5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JTR2GH1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DNR2GH3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I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??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PP13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VIRAL RESISTANCE PROTEIN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-PROTEIN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P8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TYP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TYP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GA2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PLANT DISEASE RESISTANT PROTEIN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DISEASE RESISTANCE PROTEIN I2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OTATO LATE BLIGHT RESISTANCE PROTEIN R3A [SOLANUM TUBEROS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I2C-5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3A-LIK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PLANT DISEASE RESISTANT PROTEIN, IDENTICAL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-NBS-LRR [HELIANTHUS ANNUUS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XA1 [ORYZA SATIVA (INDICA CULTIVAR-GROUP)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B-LRR TYPE DISEASE RESISTANCE PROTEIN RPS1-K-1 [GLYCINE MAX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B-LRR TYPE DISEASE RESISTANCE PROTEIN RPS1-K-2 [GLYCINE MAX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UST RESISTANCE PROTEIN [ZEA MAYS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YST NEMATODE RESISTANCE GENE CANDIDATE-LIKE [AEGILOPS TAUSCHII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GO35 NBS-LRR [AEGILOPS TAUSCHII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 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UNCHARACTERIZED PROTEIN HMA7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OWDERY MILDEW RESISTANCE PROTEIN PM3B [TRITICUM AESTIV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IGHT RESISTANCE PROTEIN SH10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PTA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ATE BLIGHT RESISTANCE PROTEIN RPI-STO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DISEASE RESISTANCE PROTEIN RGA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UTATIVE DISEASE RESISTANT PROTEIN RGA2 [SOLANUM BULBOCASTAN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IGHT RESISTANCE PROTEIN SH10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M1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BS-LRR TYP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BS-LRR TYPE DISEASE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BS-LRR TYPE R PROTEIN, NBS4-PI [ORYZA SATIVA IND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BS-LRR DISEASE RESISTANCE PROTEIN [ORYZA SATIVA IND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IZ-T [ORYZA SATIVA JAPON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IB [ORYZA SATIVA JAPON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I-TA PROTEIN [ORYZA SATIVA JAPON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ESISTANCE PROTEIN LR10 [TRITICUM AESTIV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-NBS-LRR PI36 [ORYZA SATIVA INDICA GROUP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LA1 [HORDEUM CHILENS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LA6 PROTEIN [HORDEUM VULGARE SUBSP. VULGAR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LA10 [HORDEUM VULGAR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LA12 [HORDEUM VULGARE SUBSP. VULGAR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-NBS-LRR RESISTANCE PROTEIN MLA13 [HORDEUM VULGARE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PM1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2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EASE RESISTANCE PROTEIN RPM1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 SITE-LEUCINE RICH REPEAT PROTEIN (FRAG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 SITE-LEUCINE RICH REPEAT PROTEIN (FRAG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UNCHARACTERIZED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UNCHARACTERIZED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56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UNCHARACTERIZED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JHL06P13.14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UTATIVE UNCHARACTERIZED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CLEOTIDE BINDING SITE-LEUCINE RICH REPEAT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S5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S2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-NB-LRR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ESISTANCE PROTEIN CANDIDATE RGC2B [LACTUCA SATIV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S-LRR RESISTANC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ESISTANCE-LIKE PROTEIN P2-A [LINUM USITATISSIM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S4 (RESISTANT TO P. SYRINGAE 4); RECEPTOR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6 [LINUM USITATISSIM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UST RESISTANCE PROTEIN M [LINUM USITATISSIM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DICTED: HYPOTHETICAL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-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-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-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-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UCINE-RICH REPEAT-CONTAIN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MV RESISTANCE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 BIND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 BIND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 BIND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 BINDING PROTEIN, PUTATIV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R-NBS-LRR DISEAS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P4 (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P5 (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IR-NBS-LRR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PP1 [ARABIDOPSIS THALIA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EMATODE RESISTANCE PROTEIN [SOLANUM TUBEROS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66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 PROTEIN (FRAGMENT)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MATODE RESISTANCE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L2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GENE-LIK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STANCE GENE-LIK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ESISTANCE GENE-LIKE [SOLANUM TUBEROSUM SUBSP. ANDIGEN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L2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L2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 [NICOTIANA GLUTINOSA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s-ES" sz="5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BACTERIAL SPOT DISEASE RESISTANCE PROTEIN 4 [SOLANUM LYCOPERSICUM]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48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-LIKE PROTEIN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81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992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ACTERIAL SPOT DISEASE RESISTANCE PROTEIN 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Line 1235"/>
          <p:cNvSpPr/>
          <p:nvPr/>
        </p:nvSpPr>
        <p:spPr>
          <a:xfrm>
            <a:off x="7354800" y="50590440"/>
            <a:ext cx="360360" cy="0"/>
          </a:xfrm>
          <a:prstGeom prst="line">
            <a:avLst/>
          </a:prstGeom>
          <a:ln w="1260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237"/>
          <p:cNvSpPr/>
          <p:nvPr/>
        </p:nvSpPr>
        <p:spPr>
          <a:xfrm>
            <a:off x="7524720" y="41589360"/>
            <a:ext cx="0" cy="9001080"/>
          </a:xfrm>
          <a:prstGeom prst="line">
            <a:avLst/>
          </a:prstGeom>
          <a:ln w="1260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238"/>
          <p:cNvSpPr/>
          <p:nvPr/>
        </p:nvSpPr>
        <p:spPr>
          <a:xfrm>
            <a:off x="7354800" y="41589360"/>
            <a:ext cx="360360" cy="0"/>
          </a:xfrm>
          <a:prstGeom prst="line">
            <a:avLst/>
          </a:prstGeom>
          <a:ln w="1260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239"/>
          <p:cNvSpPr/>
          <p:nvPr/>
        </p:nvSpPr>
        <p:spPr>
          <a:xfrm>
            <a:off x="7354800" y="41516280"/>
            <a:ext cx="360360" cy="0"/>
          </a:xfrm>
          <a:prstGeom prst="line">
            <a:avLst/>
          </a:prstGeom>
          <a:ln w="1260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242"/>
          <p:cNvSpPr/>
          <p:nvPr/>
        </p:nvSpPr>
        <p:spPr>
          <a:xfrm>
            <a:off x="7524720" y="36907920"/>
            <a:ext cx="0" cy="4609800"/>
          </a:xfrm>
          <a:prstGeom prst="line">
            <a:avLst/>
          </a:prstGeom>
          <a:ln w="1260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243"/>
          <p:cNvSpPr/>
          <p:nvPr/>
        </p:nvSpPr>
        <p:spPr>
          <a:xfrm>
            <a:off x="7354800" y="36907920"/>
            <a:ext cx="360360" cy="0"/>
          </a:xfrm>
          <a:prstGeom prst="line">
            <a:avLst/>
          </a:prstGeom>
          <a:ln w="1260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244"/>
          <p:cNvSpPr/>
          <p:nvPr/>
        </p:nvSpPr>
        <p:spPr>
          <a:xfrm>
            <a:off x="7354800" y="36836280"/>
            <a:ext cx="360360" cy="0"/>
          </a:xfrm>
          <a:prstGeom prst="line">
            <a:avLst/>
          </a:prstGeom>
          <a:ln w="12600">
            <a:solidFill>
              <a:srgbClr val="00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245"/>
          <p:cNvSpPr/>
          <p:nvPr/>
        </p:nvSpPr>
        <p:spPr>
          <a:xfrm>
            <a:off x="7524720" y="112680"/>
            <a:ext cx="0" cy="36725400"/>
          </a:xfrm>
          <a:prstGeom prst="line">
            <a:avLst/>
          </a:prstGeom>
          <a:ln w="12600">
            <a:solidFill>
              <a:srgbClr val="00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246"/>
          <p:cNvSpPr/>
          <p:nvPr/>
        </p:nvSpPr>
        <p:spPr>
          <a:xfrm>
            <a:off x="7354800" y="112680"/>
            <a:ext cx="360360" cy="0"/>
          </a:xfrm>
          <a:prstGeom prst="line">
            <a:avLst/>
          </a:prstGeom>
          <a:ln w="12600">
            <a:solidFill>
              <a:srgbClr val="00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247"/>
          <p:cNvSpPr/>
          <p:nvPr/>
        </p:nvSpPr>
        <p:spPr>
          <a:xfrm>
            <a:off x="7812000" y="15809760"/>
            <a:ext cx="13320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C(I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248"/>
          <p:cNvSpPr/>
          <p:nvPr/>
        </p:nvSpPr>
        <p:spPr>
          <a:xfrm>
            <a:off x="7812000" y="38781000"/>
            <a:ext cx="13320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C(II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49"/>
          <p:cNvSpPr/>
          <p:nvPr/>
        </p:nvSpPr>
        <p:spPr>
          <a:xfrm>
            <a:off x="7812000" y="46124640"/>
            <a:ext cx="13320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TI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9T16:06:35Z</dcterms:created>
  <dc:creator>Gabitoz</dc:creator>
  <dc:description/>
  <dc:language>en-US</dc:language>
  <cp:lastModifiedBy>ROBERTO</cp:lastModifiedBy>
  <dcterms:modified xsi:type="dcterms:W3CDTF">2011-12-02T16:34:48Z</dcterms:modified>
  <cp:revision>9</cp:revision>
  <dc:subject/>
  <dc:title>Diapositiva 1</dc:title>
</cp:coreProperties>
</file>